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682B3D-501D-495B-8137-59B915065B1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0AC3D7-2DDB-4527-BBDE-0854D515E9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9592B9-9ABB-4353-865C-CAA9733006B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5B57F0-F19A-44E6-830D-81249714E5A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8144CA-B9B0-42FB-88A5-9EA9537337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D9A309-DF6E-4A17-B407-52A398B9A2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0DA8C0-CC37-43A1-A4B2-063CACFF6B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C3570B-548B-4572-A22B-F5ABCFFB82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0EEE46-D56C-4C58-808E-2FF3B26571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C2A557-3BF1-464A-ABAA-2D9570FD94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201CAB-42BC-4C0C-921C-E13AA89B89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6B7213-60A2-42A6-8941-77B1FB9164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4E59554-18A1-43ED-A159-B3EBC78420B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9"/>
          <p:cNvSpPr/>
          <p:nvPr/>
        </p:nvSpPr>
        <p:spPr>
          <a:xfrm>
            <a:off x="245880" y="260280"/>
            <a:ext cx="8471160" cy="544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B-1      ATGAATATGA-AAATTAAAAATGTATTTAGCTTCTTAGCACTTACAGCTATGGCCAGTCAAACATTAGTC-TACCCCGTATATGCACAACCAATTATAGAGAATTATGCTAATCAAGAAA  11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</a:t>
            </a: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|||||||| | ||||||||||||||||||| || ||| ||||||||||||||   |||||||| ||| || ||    |||||||||||| | | || | | ||| || | |||| |||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JGS1987   ATGAATAT-ACAAATTAAAAATGTATTTAGTTTTTTAACACTTACAGCTATGATAAGTCAAACGTTA-TCATATAATGTATATGCACAAACTACTACACAAAATGATACCAATC-AGAA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B-1      -TAGAAATGATAAATGAAGATATTCT-TCCAACTAATGGATTAATGAGCTATTATTTCACTGATGAACATTTCAAAGACTTAGAATTAATGGCACCAATCAAAAATGGAGATTTTACATT  23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  </a:t>
            </a: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|||||| | ||||||| |||  || | ||| ||| ||||||||| | ||||||||  | ||||||||||| || || |||||||||||||| |||||||||||||| ||||| | |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JGS1987   GAAGAAATAACAAATGAAAATACACTAT-CAAGTAACGGATTAATGGGATATTATTTTGCAGATGAACATTTTAAGGATTTAGAATTAATGGCGCCAATCAAAAATGGTGATTTGAAAT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B-1      TAAAGGAAATG-AAGTAGACAAGCTTTTAACTAAAGATAA---AAGTATAAAATCTATCCGTTGGACAGGAAGAATAATTCCTTCTGAAGATGGT-ATATATACATTATCAACTGATAGA  35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</a:t>
            </a: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| || |||| | |||||||||||||||||||| |||||||   |||||||||||||||||| ||||||||||| ||||||||||||||||||||| | ||||| ||| ||||||||||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JGS1987   TGAA-GAAAAGAAAGTAGACAAGCTTTTAACTGAAGATAATTCAAGTATAAAATCTATCCGATGGACAGGAAGGATAATTCCTTCTGAAGATGGTGA-ATATATATTGTCAACTGATAG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B-1      GATGATGTATTGATGCAAATAAATTCAAAAGATGATATAGCAAAAACACTT-AGTATTAATATGAAAAAAGGACAAGAATATACTATTAGAATAGAAGTACAAGGA-GAAAATTTAGGTT  46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 </a:t>
            </a: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|||||||||| |||||||||||| | ||||  ||||| |||||||||||| ||  |||||||||||||||| || | ||| | ||||||||||||| ||||| ||  ||||||||||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JGS1987   AATGATGTATTAATGCAAATAAATGCTAAAGGGGATATTGCAAAAACACTTAAG-GTTAATATGAAAAAAGGTCAGGCATACAATATTAGAATAGAAATACAA-GACAAAAATTTAGGT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B-1      CAATTGATACTATGTCAGCCCCTAAACTTTATTGGGAGTTAAATGGAAATAAAACAATTATACCTGAAGAAAACTTATTTTTGAGGGATTATTCTAAAATAGATGAAAATGATCCATTTA  58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</a:t>
            </a: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||||||||| | | || |  ||||||||||||||||| |||||||||||||||||| | |||||||||||||||||||||||  | ||||| ||||||||||||||||||||||| ||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JGS1987   CAATTGATAATTTATCTGTTCCTAAACTTTATTGGGAATTAAATGGAAATAAAACAGTAATACCTGAAGAAAACTTATTTTTCCGAGATTACTCTAAAATAGATGAAAATGATCCGTTT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B-1      TACCTAATAATAAtttttttGAT-TTACA--ATTTAGATCAAGTTTTGG-AGATGAGGATTTAGATACTGATAATGATAATATTCCAGATTCTTATGAAATAAATGGATATACTATTAAA  7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</a:t>
            </a: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||||||||||||||||||||||| | | |   |||||  | ||  | || |||||| ||||||||||||||||||||||||||||||||| ||||||||| |||||| |||||||| |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JGS1987   TACCTAATAATAATTTTTTTGATGTAAGATTTTTTAGCGC-AGCCTGGGAAGATGAAGATTTAGATACTGATAATGATAATATTCCAGATGCTTATGAAAAAAATGGCTATACTATCAA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B-1      GATTCAATCGCAATAAAATGGGATGATAGTCTTGCCGAACAAGGATATAAAAAATATGTATCAAGTTATTTACAATCAAATACTGCTGGTGATCCATATACAGACTATGAGAAAGCTTCC  82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</a:t>
            </a: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|||||||| ||| |||||||| |||||||| |||| |||||||||||||||||||||||||||||||||||| |||||||||| |||||||| ||||||||||| ||| | ||||||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JGS1987   GATTCAATTGCAGTAAAATGGAATGATAGTTTTGCAGAACAAGGATATAAAAAATATGTATCAAGTTATTTAGAATCAAATACCGCTGGTGACCCATATACAGATTATCAAAAAGCTT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B-1      GGTTCTTTTGATAAAGCTATAAAAGCT-GAAGCAAGGGATCCTTTAGTTGCAGCTTATCCAATTGTTGGAGTTGGAATGGAAAAACTAATTATATCTACTAATGAACATGCTTCAACTGA  94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</a:t>
            </a: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|||||| |||||||||||||||||  | |||||||| ||||||||||||||||| |||||| |||||||||| || ||||||||  |||||||||||||||||||||||||||||| |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JGS1987   GGTTCTATTGATAAAGCTATAAAA-TTAGAAGCAAGAGATCCTTTAGTTGCAGCATATCCAGTTGTTGGAGTAGGTATGGAAAATTTAATTATATCTACTAATGAACATGCTTCAAGTG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B-1      TCAGGGCAAAACAGTTTCTAGAGCTACAACAAATAGTAAAACTGACT-CAAATACAGGTGGTGTATCTGTTAGTGCTGGTTATCAAAATGGTTTTACAGGTAGTATAACTACAAACTATT  106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</a:t>
            </a: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||| || |||||||||||||| ||||| ||||||||||||||||| | ||||||||| ||| |||||| |||||||||| ||||||||||| ||||| |||| ||||||||||| |||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JGS1987   TCAAGGAAAAACAGTTTCTAGGGCTACTACAAATAGTAAAACTGA-TGCAAATACAGTTGGAGTATCTATTAGTGCTGGATATCAAAATGGATTTACTGGTAATATAACTACAAGCTAT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B-1      CTCATACAACAGAGAATTCAACTTCTGTACAAGATAGTAATGGAGAATCATGGAACACTGGATTAAGTATTAATAAAGGTGAATCAGCATATATAAATGCAAATGTTAGATATTATAATA  118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</a:t>
            </a: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|||| |||||||| ||||||||| |||| |||||||||||||||||||||||||| |||||||||||||| |||||||| |||||||||||||||||||| ||||| |||||||||||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JGS1987   CTCACACAACAGATAATTCAACTGCTGTGCAAGATAGTAATGGAGAATCATGGAATACTGGATTAAGTATAAATAAAGGAGAATCAGCATATATAAATGCCAATGTAAGATATTATAAT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B-1      CTGGTACTGCACCTATGTATAAAGTAACACCAACAACAAATTTAGTATTAGATGGAGACACATTGA-CAACTATTAAAGCACAGGATAATCAAATTGGTAATAACTTATCTCCAAATGAA  13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</a:t>
            </a: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||||||||||||||||||| |||||||| |||||||| |||||||||||||||||||| ||||| | |||||||||||||||||||||||||||||||||||||||||||||||||||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JGS1987   CTGGTACTGCACCTATGTACAAAGTAACTCCAACAACCAATTTAGTATTAGATGGAGAGACATT-AGCAACTATTAAAGCACAGGATAATCAAATTGGTAATAACTTATCTCCAAATGA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10"/>
          <p:cNvSpPr/>
          <p:nvPr/>
        </p:nvSpPr>
        <p:spPr>
          <a:xfrm>
            <a:off x="324000" y="5803920"/>
            <a:ext cx="8424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Figure S5.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Comparison of nucleotide sequence of the variant </a:t>
            </a:r>
            <a:r>
              <a:rPr b="1" i="1" lang="ja-JP" sz="1400" spc="-1" strike="noStrike">
                <a:solidFill>
                  <a:srgbClr val="000000"/>
                </a:solidFill>
                <a:latin typeface="Arial"/>
              </a:rPr>
              <a:t>ibp </a:t>
            </a: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gene of pCPPB-1 against the </a:t>
            </a:r>
            <a:r>
              <a:rPr b="1" i="1" lang="ja-JP" sz="1400" spc="-1" strike="noStrike">
                <a:solidFill>
                  <a:srgbClr val="000000"/>
                </a:solidFill>
                <a:latin typeface="Arial"/>
              </a:rPr>
              <a:t>ibp</a:t>
            </a: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 gene of classical type E isolates (JGS1987)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 Box 5"/>
          <p:cNvSpPr/>
          <p:nvPr/>
        </p:nvSpPr>
        <p:spPr>
          <a:xfrm>
            <a:off x="102960" y="189000"/>
            <a:ext cx="8471160" cy="5812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B-1      ACATATCCTAAGAAAGGGCTGTCTCCTTTAGCTCTTAATACAATGGATCAATTTAGTTCTAAATTAATTCCAATAAACTATGATCAACTaaaaaaaTTAGATGCTGGAAAGCAAATTAAA  142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</a:t>
            </a: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||||||||||| ||||| || ||||||||||||||||| |||||||||||||||| | |||  |||||||||||||| || |||||||| |||||||||||| ||||||| |||||||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JGS1987   ACATATCCTAAAAAAGGACTTTCTCCTTTAGCTCTTAACACAATGGATCAATTTAATGCTAGGTTAATTCCAATAAATTACGATCAACTTAAAAAATTAGATTCTGGAAAACAAATTAA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B-1      CTAGAAACAACTCAAGTAAGTGGAAATTTTGGTACAAAAAATAATCAAGGACAAATAGTTACTGAGGGAAATAGTTGGTCCGATTATATAAGTCAAATTGATAGCATTTCTGCATCTCTT  154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 </a:t>
            </a: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|||||||||| |||||||||||||||| ||| || ||||||| ||||||||||||| |||| || ||||||||||||||  | ||||||||||||||||||||| ||||||||||| 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JGS1987   TTAGAAACAACACAAGTAAGTGGAAATTATGGAACTAAAAATAGTCAAGGACAAATAATTACAGAAGGAAATAGTTGGTCTAACTATATAAGTCAAATTGATAGCGTTTCTGCATCTAT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B-1      ATTCTAGATACAGGAAATGAAACATTTGAAAGACGTGTTGCTGCTAAAGATTCAA-GTAATCCTGAAGATAAAACACCTGA-ATTAACAATTGGAGAAGCAATTGAAAAAGCATTTGGTG  166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</a:t>
            </a: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|| || |||||||||| | ||||||||||||| ||||| |||||||||||  ||| | ||||| ||||||||||| ||||| ||| |||||||||||||||||| ||||||| ||| |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JGS1987   ATACTGGATACAGGAAGTCAAACATTTGAAAGGCGTGTGGCTGCTAAAGA-GCAAGGAAATCCAGAAGATAAAACTCCTGAGATT-ACAATTGGAGAAGCAATTAAAAAAGCTTTTAGT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B-1      CTACTAAGAATGGTGGTTTATTATATTTCAATGAAATTCCAATTGATGAAAGTTGTGTTGAACTTATATTTGATGATAATACAGCT-AACATAATTAAA-AATAGCTTAAAA-ACTTTAG  177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</a:t>
            </a: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||||||| |||||||  ||||||||||| |||| ||||||||||||||| || |||||||||||||||||||||||||||||| || || ||||||||| || |  |||||| | |||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JGS1987   CTACTAAAAATGGTGAATTATTATATTTTAATGGAATTCCAATTGATGAGAGCTGTGTTGAACTTATATTTGATGATAATACATCTGAA-ATAATTAAAGAACA-ATTAAAATA-TTT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B-1      ATGATAAAAAGATATATAATGTTAAACTAGAAAGAGGTATGAATATACTTATAAAAACACCTTCATATTTTACTAATTTTGATGGACATAACACA-TTCCCTAAATCATGGAGTAATATT  189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</a:t>
            </a: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|||||||||||||||||||||||||||| |||||||| |||||||||||||||||    ||||||||||||||||||||||||| | |||| | | || |||   |||||||||||||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JGS1987   ATGATAAAAAGATATATAATGTTAAACTTGAAAGAGGAATGAATATACTTATAAAGGTGCCTTCATATTTTACTAATTTTGATGAATATAATA-ATTTTCCTGCTTCATGGAGTAATAT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B-1      AATACTCAAAA-TAAGGATGGTTTACAAGGTACAGCAAATGAAGTCAA-TGGTGAAACAAAAATTACATTACCTATGTCTAATTTAAAACCCTATAAACGTTATATTTTTAGTGGATATT  201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 </a:t>
            </a: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||||| ||||  || |||||||||||| ||  ||||||| |||| ||  || || ||||| |||| | ||||||||||||| ||||||||||||||||| ||| |||||||||||||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JGS1987   GATACTAAAAACCAA-GATGGTTTACAAAGTGTAGCAAAT-AAGTTAAGCGGAGAGACAAAGATTATAATACCTATGTCTAAATTAAAACCCTATAAACGCTATGTTTTTAGTGGATAT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B-1      CAAA--ATCTTCTTCAGCTTCTAATTCATTAAATA-TAAATATAAAAGCAAAAGAACAGAAAACAGATCAATTT-GTATTAGATAACGGA-TATA-AAAAGTTTAGTTATGAATTTGAAA  212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</a:t>
            </a: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||||  |||  ||||| ||||||||||| | || | ||||||||||| ||||||||||||||||||||  |||| |||  ||| ||  || |||| |||| |||||||||||||||||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JGS1987   CAAAGGATC--CTTCAACTTCTAATTCAAT-AACAGTAAATATAAAATCAAAAGAACAGAAAACAGAT-TATTTAGTACCAGAGAA-AGATTATACAAAA-TTTAGTTATGAATTTGAA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B-1      CAACAGGAAAAGATTCTCCCAATATAGAAATAACATTAACTAGTAATGATAAAATATTTTTAGATAATTTATCTATTACAGAATTAAATAGTACTCCTGAAATATTAAAAGAACCAGAAA  224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</a:t>
            </a: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|||| |||||||||||| |  ||||||||||||||||||| |||| || |  ||||||||||||||||||||||||||||||||||||||||||||||||||||||||||||||||||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JGS1987   CAACCGGAAAAGATTCTTCTGATATAGAAATAACATTAACAAGTAGTGGTGTAATATTTTTAGATAATTTATCTATTACAGAATTAAATAGTACTCCTGAAATATTAAAAGAACCAGAA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B-1      TTAAAGTTCCAAGTGACCAAGAAATACTAGCTGCACATAACAAATATTATGCAGATATAAAGCTTGACACAAATACAGGAAACACTTATATAGATGGTATATATTTTGAGCCAACCCAAA  236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</a:t>
            </a: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|||||||||||||||||||||||||||||| |||||||||||||||||||||||||||||||||||||||||||||||||||||||||||||||||||||||||||||| ||||| ||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JGS1987   TTAAAGTTCCAAGTGACCAAGAAATACTAGATGCACATAACAAATATTATGCAGATATAAAGCTTGACACAAATACAGGAAACACTTATATAGATGGTATATATTTTGAACCAACTCAA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B-1      CTAATAAAGAAGCTCTTGATTATATTCAAAAATATAGAGTTGAAGCAACTTTGCAATATTCAGGATTCAAAGATATTGGAACTAAGGATAAAGAAGTACGTAATTATTTAGGAGATCCAA  248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</a:t>
            </a: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||||||||||||||||||||||||||||||||||||||||||||||||||||||||||||||||||| ||||||||||||||||||||||||||| ||||||||||||||||||||| 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JGS1987   CTAATAAAGAAGCTCTTGATTATATTCAAAAATATAGAGTTGAAGCAACTTTGCAATATTCAGGATTTAAAGATATTGGAACTAAGGATAAAGAAATACGTAATTATTTAGGAGATCAA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B-1      ATCAACCTAAAACTAATTATATTAATCTTAGAAGTTATTTTACTAGTGGAGAAAATGTTATGACATATAAAAAATTAAGAATATATGCAGTTACACCTGATAATAGAGAATTATTAGTGC  260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</a:t>
            </a: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| |||||||||||||||||||||||| |||||||||||||||||||||||||||||||||||||||||||||||||||||||||||||||||||||||||||||||||| ||||||||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JGS1987   ACCAACCTAAAACTAATTATATTAATTTTAGAAGTTATTTTACTAGTGGAGAAAATGTTATGACATATAAAAAATTAAGAATATATGCAGTTACACCTGATAATAGAGAGTTATTAGTG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B-1      TTAGTGTTAATTAA  262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        </a:t>
            </a: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||||||||||||||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JGS1987   TTAGTGTTAATTAA  549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6"/>
          <p:cNvSpPr/>
          <p:nvPr/>
        </p:nvSpPr>
        <p:spPr>
          <a:xfrm>
            <a:off x="324000" y="6093000"/>
            <a:ext cx="8424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Comparison of nucleotide sequence of the variant </a:t>
            </a:r>
            <a:r>
              <a:rPr b="1" i="1" lang="ja-JP" sz="1400" spc="-1" strike="noStrike">
                <a:solidFill>
                  <a:srgbClr val="000000"/>
                </a:solidFill>
                <a:latin typeface="Arial"/>
              </a:rPr>
              <a:t>ibp </a:t>
            </a: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gene of pCPPB-1 against the </a:t>
            </a:r>
            <a:r>
              <a:rPr b="1" i="1" lang="ja-JP" sz="1400" spc="-1" strike="noStrike">
                <a:solidFill>
                  <a:srgbClr val="000000"/>
                </a:solidFill>
                <a:latin typeface="Arial"/>
              </a:rPr>
              <a:t>ibp</a:t>
            </a: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 gene of classical type E isolates (JGS1987). (Continued)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04T00:01:52Z</dcterms:created>
  <dc:creator>MIYAMOTO</dc:creator>
  <dc:description/>
  <dc:language>en-US</dc:language>
  <cp:lastModifiedBy>MIYAMOTO</cp:lastModifiedBy>
  <dcterms:modified xsi:type="dcterms:W3CDTF">2011-05-04T00:04:24Z</dcterms:modified>
  <cp:revision>5</cp:revision>
  <dc:subject/>
  <dc:title>スライド 1</dc:title>
</cp:coreProperties>
</file>